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1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A543BB-E568-EC08-4CFA-574213B66CD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6893966-96F7-6A91-EEA7-9F41E635C11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EAF4D05-07F9-1E8D-7352-3C53871B44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A331B8-0963-4BD4-8CE7-5929AEDD0FBE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DA94977-BDBD-48A8-593C-C6CC35A907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F9F4B31-838B-3D28-D7E3-A299FA6F56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13B780-557B-4EDD-96E8-523AB3FD6B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96236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A97017-CC2F-EF4B-74F5-019273A0FFC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B65DD3E-E4CA-5835-4E90-DFA8478349E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BDC7773-6EE9-C22F-4713-F59EDEAB50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A331B8-0963-4BD4-8CE7-5929AEDD0FBE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63BB88A-63B1-06DE-49CC-5733AED2C7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4B0383F-82BB-B570-28E9-CDC1907E41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13B780-557B-4EDD-96E8-523AB3FD6B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49631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A088933-1C1F-7E05-ADB9-909A130D8D8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20A31D3-5F69-8D76-10D8-D483BCFF18C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73964C5-F476-6649-CC8E-E7A8826FF6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A331B8-0963-4BD4-8CE7-5929AEDD0FBE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A714C7D-34DC-256A-AEF2-CEF53FCDD0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F401583-BC47-5609-D1BD-214A3C3E67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13B780-557B-4EDD-96E8-523AB3FD6B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93268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6662393-7206-8D72-F0C5-9DD1C5264F5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8F9733B-8D45-498B-2BA2-433E8FD8CF6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9753721-2B3C-6F12-153E-5B09F1D8BB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A331B8-0963-4BD4-8CE7-5929AEDD0FBE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0E85B2C-5462-24D6-CA9D-8B0ADC6A28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2E3798D-EC77-5CD2-AFA2-A71D8B379D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13B780-557B-4EDD-96E8-523AB3FD6B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48572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BA758C-8317-7FE7-7679-B8A88863DF5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F0B78DE-4CDB-786F-14AD-51F8AFA60BB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A098768-41D6-877E-9660-BBF77FEF76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A331B8-0963-4BD4-8CE7-5929AEDD0FBE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9AB2D87-B93D-DF04-CB6F-CD411BE498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6A349ED-FF9F-FF85-C35A-91FB334FAF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13B780-557B-4EDD-96E8-523AB3FD6B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41916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7C9D588-5BA3-7BF1-CA52-B0A45A69B9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98E2EB4-1FC6-55DB-30E0-D87E1887B4A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990AA76-82A9-260D-DA4B-6558068359E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BCAD066-C8FE-1C3B-CA86-CAE06A00ED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A331B8-0963-4BD4-8CE7-5929AEDD0FBE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D161926-0D72-5B29-DA04-3CC74701F3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0164A92-C62F-DC21-53EA-ACE8529AE0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13B780-557B-4EDD-96E8-523AB3FD6B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22384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B7F0E45-BCD8-CBC6-9969-3C7EAD3A71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6DBA3FF-33B6-FC1A-1CB9-3969672A324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F057A58-C669-DE4A-27EA-95132EBA07B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14A54A9-84FD-573A-BE35-7940BD2D6D5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2B4EE3F-B359-2679-D0D6-974B677237F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7B5CE71-5F24-92A1-2BF0-54C3D35117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A331B8-0963-4BD4-8CE7-5929AEDD0FBE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B2C7F16-C808-B3D5-4D56-FCC026494F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5F5F13C-1A29-4372-6628-388BCCB71B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13B780-557B-4EDD-96E8-523AB3FD6B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30848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251DE1-722E-5D46-B123-849A8640032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8344F17-A28A-276D-82B3-CDAC10BC0E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A331B8-0963-4BD4-8CE7-5929AEDD0FBE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C47FB91-A174-2DA4-42EC-437C7D899C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8E0A3C9-85B9-051B-B96B-199A3C44F4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13B780-557B-4EDD-96E8-523AB3FD6B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27544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242C21D-336F-DED4-A6DC-85A228AC88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A331B8-0963-4BD4-8CE7-5929AEDD0FBE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2FB3035-AEA1-5438-D60C-5E73D04389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5D9466A-CB6A-B302-3D12-5CB4937B84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13B780-557B-4EDD-96E8-523AB3FD6B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95470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84921B-F38A-C0CE-F84E-DDFA4EE94A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1223A28-9D47-E90D-DD3B-D846A85F4F4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0E5C640-7C63-B319-5B8D-A5780824606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E142E8F-9EE7-2753-40AA-8A090833D5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A331B8-0963-4BD4-8CE7-5929AEDD0FBE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49A4EB8-D0DE-8D5D-DD51-38CEAC020D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1F9C6B5-AEBA-8D21-D4D0-2A39D56182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13B780-557B-4EDD-96E8-523AB3FD6B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61155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9C8EB3-5D84-2483-6717-01CB9179D6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ABA2C90-46AB-8E66-B28D-41B28FDEC13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4D289A1-F282-B30B-352F-1C255E618FC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A77CEDF-7344-3FB1-FCE9-B2474D453A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A331B8-0963-4BD4-8CE7-5929AEDD0FBE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A7D8658-3D0B-5AB4-97E4-28698B2A3D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A84BDE2-128A-6DAE-7C3C-936D1C3A9F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13B780-557B-4EDD-96E8-523AB3FD6B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35018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FCE37D4-608B-930D-928A-1B7F0602401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6EF6468-522D-68F1-5E79-86220BA8847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1F38D1A-225B-DE3B-A7DF-B7C622B1ED1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A331B8-0963-4BD4-8CE7-5929AEDD0FBE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C85E4FA-AFF3-8091-6A0A-44A0CED652B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3E493F7-719B-D646-CC93-C67FAD279C9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13B780-557B-4EDD-96E8-523AB3FD6B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9358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3" Type="http://schemas.openxmlformats.org/officeDocument/2006/relationships/image" Target="../media/image1.emf"/><Relationship Id="rId7" Type="http://schemas.openxmlformats.org/officeDocument/2006/relationships/image" Target="../media/image3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3.bin"/><Relationship Id="rId5" Type="http://schemas.openxmlformats.org/officeDocument/2006/relationships/image" Target="../media/image2.emf"/><Relationship Id="rId4" Type="http://schemas.openxmlformats.org/officeDocument/2006/relationships/oleObject" Target="../embeddings/oleObject2.bin"/><Relationship Id="rId9" Type="http://schemas.openxmlformats.org/officeDocument/2006/relationships/image" Target="../media/image4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DF8D8033-202C-F590-450E-8B81055C1327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029947" y="66122"/>
          <a:ext cx="3849687" cy="29749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3849491" imgH="2974512" progId="Prism10.Document">
                  <p:embed/>
                </p:oleObj>
              </mc:Choice>
              <mc:Fallback>
                <p:oleObj name="Prism 10" r:id="rId2" imgW="3849491" imgH="2974512" progId="Prism10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DF8D8033-202C-F590-450E-8B81055C132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029947" y="66122"/>
                        <a:ext cx="3849687" cy="29749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494A8AB5-4688-2FEC-E5BE-DEF0CB25D648}"/>
              </a:ext>
            </a:extLst>
          </p:cNvPr>
          <p:cNvGraphicFramePr>
            <a:graphicFrameLocks noChangeAspect="1"/>
          </p:cNvGraphicFramePr>
          <p:nvPr/>
        </p:nvGraphicFramePr>
        <p:xfrm>
          <a:off x="5656442" y="66121"/>
          <a:ext cx="3849687" cy="29749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" imgW="3849491" imgH="2974512" progId="Prism10.Document">
                  <p:embed/>
                </p:oleObj>
              </mc:Choice>
              <mc:Fallback>
                <p:oleObj name="Prism 10" r:id="rId4" imgW="3849491" imgH="2974512" progId="Prism10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494A8AB5-4688-2FEC-E5BE-DEF0CB25D64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5656442" y="66121"/>
                        <a:ext cx="3849687" cy="29749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4FB9BABB-4061-7B92-D01E-D21D0A4878FB}"/>
              </a:ext>
            </a:extLst>
          </p:cNvPr>
          <p:cNvGraphicFramePr>
            <a:graphicFrameLocks noGrp="1"/>
          </p:cNvGraphicFramePr>
          <p:nvPr/>
        </p:nvGraphicFramePr>
        <p:xfrm>
          <a:off x="2504572" y="2045323"/>
          <a:ext cx="941696" cy="267660"/>
        </p:xfrm>
        <a:graphic>
          <a:graphicData uri="http://schemas.openxmlformats.org/drawingml/2006/table">
            <a:tbl>
              <a:tblPr/>
              <a:tblGrid>
                <a:gridCol w="941696">
                  <a:extLst>
                    <a:ext uri="{9D8B030D-6E8A-4147-A177-3AD203B41FA5}">
                      <a16:colId xmlns:a16="http://schemas.microsoft.com/office/drawing/2014/main" val="1487705710"/>
                    </a:ext>
                  </a:extLst>
                </a:gridCol>
              </a:tblGrid>
              <a:tr h="267660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1" i="1" u="none" strike="noStrike" dirty="0">
                          <a:effectLst/>
                          <a:latin typeface="Arial" panose="020B0604020202020204" pitchFamily="34" charset="0"/>
                        </a:rPr>
                        <a:t>p </a:t>
                      </a:r>
                      <a:r>
                        <a:rPr lang="en-US" sz="1000" b="1" i="0" u="none" strike="noStrike" dirty="0">
                          <a:effectLst/>
                          <a:latin typeface="Arial" panose="020B0604020202020204" pitchFamily="34" charset="0"/>
                        </a:rPr>
                        <a:t>= 0.1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18708764"/>
                  </a:ext>
                </a:extLst>
              </a:tr>
            </a:tbl>
          </a:graphicData>
        </a:graphic>
      </p:graphicFrame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04351BCB-8756-A71F-E8FD-DC3098529B74}"/>
              </a:ext>
            </a:extLst>
          </p:cNvPr>
          <p:cNvGraphicFramePr>
            <a:graphicFrameLocks noGrp="1"/>
          </p:cNvGraphicFramePr>
          <p:nvPr/>
        </p:nvGraphicFramePr>
        <p:xfrm>
          <a:off x="6231838" y="2051727"/>
          <a:ext cx="941696" cy="267660"/>
        </p:xfrm>
        <a:graphic>
          <a:graphicData uri="http://schemas.openxmlformats.org/drawingml/2006/table">
            <a:tbl>
              <a:tblPr/>
              <a:tblGrid>
                <a:gridCol w="941696">
                  <a:extLst>
                    <a:ext uri="{9D8B030D-6E8A-4147-A177-3AD203B41FA5}">
                      <a16:colId xmlns:a16="http://schemas.microsoft.com/office/drawing/2014/main" val="1487705710"/>
                    </a:ext>
                  </a:extLst>
                </a:gridCol>
              </a:tblGrid>
              <a:tr h="267660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1" i="1" u="none" strike="noStrike" dirty="0">
                          <a:effectLst/>
                          <a:latin typeface="Arial" panose="020B0604020202020204" pitchFamily="34" charset="0"/>
                        </a:rPr>
                        <a:t>p </a:t>
                      </a:r>
                      <a:r>
                        <a:rPr lang="en-US" sz="1000" b="1" i="0" u="none" strike="noStrike" dirty="0">
                          <a:effectLst/>
                          <a:latin typeface="Arial" panose="020B0604020202020204" pitchFamily="34" charset="0"/>
                        </a:rPr>
                        <a:t>= 0.0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18708764"/>
                  </a:ext>
                </a:extLst>
              </a:tr>
            </a:tbl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55FC01AA-2A6A-CA77-4678-1AC557A28AD5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029947" y="3097507"/>
          <a:ext cx="3854450" cy="29749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6" imgW="3854172" imgH="2974512" progId="Prism10.Document">
                  <p:embed/>
                </p:oleObj>
              </mc:Choice>
              <mc:Fallback>
                <p:oleObj name="Prism 10" r:id="rId6" imgW="3854172" imgH="2974512" progId="Prism10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55FC01AA-2A6A-CA77-4678-1AC557A28AD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2029947" y="3097507"/>
                        <a:ext cx="3854450" cy="29749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97D04B36-C09B-D469-0FF8-6D8C9B1E74F8}"/>
              </a:ext>
            </a:extLst>
          </p:cNvPr>
          <p:cNvGraphicFramePr>
            <a:graphicFrameLocks noChangeAspect="1"/>
          </p:cNvGraphicFramePr>
          <p:nvPr/>
        </p:nvGraphicFramePr>
        <p:xfrm>
          <a:off x="5726533" y="3041096"/>
          <a:ext cx="3854450" cy="29749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8" imgW="3854172" imgH="2974512" progId="Prism10.Document">
                  <p:embed/>
                </p:oleObj>
              </mc:Choice>
              <mc:Fallback>
                <p:oleObj name="Prism 10" r:id="rId8" imgW="3854172" imgH="2974512" progId="Prism10.Document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97D04B36-C09B-D469-0FF8-6D8C9B1E74F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5726533" y="3041096"/>
                        <a:ext cx="3854450" cy="29749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Table 7">
            <a:extLst>
              <a:ext uri="{FF2B5EF4-FFF2-40B4-BE49-F238E27FC236}">
                <a16:creationId xmlns:a16="http://schemas.microsoft.com/office/drawing/2014/main" id="{348247E5-5C2C-DFFA-F9B0-F21FABD407DE}"/>
              </a:ext>
            </a:extLst>
          </p:cNvPr>
          <p:cNvGraphicFramePr>
            <a:graphicFrameLocks noGrp="1"/>
          </p:cNvGraphicFramePr>
          <p:nvPr/>
        </p:nvGraphicFramePr>
        <p:xfrm>
          <a:off x="2504572" y="5018177"/>
          <a:ext cx="941696" cy="267660"/>
        </p:xfrm>
        <a:graphic>
          <a:graphicData uri="http://schemas.openxmlformats.org/drawingml/2006/table">
            <a:tbl>
              <a:tblPr/>
              <a:tblGrid>
                <a:gridCol w="941696">
                  <a:extLst>
                    <a:ext uri="{9D8B030D-6E8A-4147-A177-3AD203B41FA5}">
                      <a16:colId xmlns:a16="http://schemas.microsoft.com/office/drawing/2014/main" val="1487705710"/>
                    </a:ext>
                  </a:extLst>
                </a:gridCol>
              </a:tblGrid>
              <a:tr h="267660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1" i="1" u="none" strike="noStrike" dirty="0">
                          <a:effectLst/>
                          <a:latin typeface="Arial" panose="020B0604020202020204" pitchFamily="34" charset="0"/>
                        </a:rPr>
                        <a:t>p </a:t>
                      </a:r>
                      <a:r>
                        <a:rPr lang="en-US" sz="1000" b="1" i="0" u="none" strike="noStrike" dirty="0">
                          <a:effectLst/>
                          <a:latin typeface="Arial" panose="020B0604020202020204" pitchFamily="34" charset="0"/>
                        </a:rPr>
                        <a:t>= 0.2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18708764"/>
                  </a:ext>
                </a:extLst>
              </a:tr>
            </a:tbl>
          </a:graphicData>
        </a:graphic>
      </p:graphicFrame>
      <p:graphicFrame>
        <p:nvGraphicFramePr>
          <p:cNvPr id="9" name="Table 8">
            <a:extLst>
              <a:ext uri="{FF2B5EF4-FFF2-40B4-BE49-F238E27FC236}">
                <a16:creationId xmlns:a16="http://schemas.microsoft.com/office/drawing/2014/main" id="{3A47B80C-CA5C-74AE-2A56-850BA40B8CBF}"/>
              </a:ext>
            </a:extLst>
          </p:cNvPr>
          <p:cNvGraphicFramePr>
            <a:graphicFrameLocks noGrp="1"/>
          </p:cNvGraphicFramePr>
          <p:nvPr/>
        </p:nvGraphicFramePr>
        <p:xfrm>
          <a:off x="6231838" y="5026702"/>
          <a:ext cx="941696" cy="267660"/>
        </p:xfrm>
        <a:graphic>
          <a:graphicData uri="http://schemas.openxmlformats.org/drawingml/2006/table">
            <a:tbl>
              <a:tblPr/>
              <a:tblGrid>
                <a:gridCol w="941696">
                  <a:extLst>
                    <a:ext uri="{9D8B030D-6E8A-4147-A177-3AD203B41FA5}">
                      <a16:colId xmlns:a16="http://schemas.microsoft.com/office/drawing/2014/main" val="1487705710"/>
                    </a:ext>
                  </a:extLst>
                </a:gridCol>
              </a:tblGrid>
              <a:tr h="267660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1" i="1" u="none" strike="noStrike" dirty="0">
                          <a:effectLst/>
                          <a:latin typeface="Arial" panose="020B0604020202020204" pitchFamily="34" charset="0"/>
                        </a:rPr>
                        <a:t>p </a:t>
                      </a:r>
                      <a:r>
                        <a:rPr lang="en-US" sz="1000" b="1" i="0" u="none" strike="noStrike" dirty="0">
                          <a:effectLst/>
                          <a:latin typeface="Arial" panose="020B0604020202020204" pitchFamily="34" charset="0"/>
                        </a:rPr>
                        <a:t>= 0.1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18708764"/>
                  </a:ext>
                </a:extLst>
              </a:tr>
            </a:tbl>
          </a:graphicData>
        </a:graphic>
      </p:graphicFrame>
      <p:sp>
        <p:nvSpPr>
          <p:cNvPr id="14" name="TextBox 13">
            <a:extLst>
              <a:ext uri="{FF2B5EF4-FFF2-40B4-BE49-F238E27FC236}">
                <a16:creationId xmlns:a16="http://schemas.microsoft.com/office/drawing/2014/main" id="{D08330D4-0F51-CD1D-40B6-A075C7999CEC}"/>
              </a:ext>
            </a:extLst>
          </p:cNvPr>
          <p:cNvSpPr txBox="1"/>
          <p:nvPr/>
        </p:nvSpPr>
        <p:spPr>
          <a:xfrm>
            <a:off x="5911717" y="330128"/>
            <a:ext cx="3000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B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E1180DF8-02BC-8783-A275-442CB5B76074}"/>
              </a:ext>
            </a:extLst>
          </p:cNvPr>
          <p:cNvSpPr txBox="1"/>
          <p:nvPr/>
        </p:nvSpPr>
        <p:spPr>
          <a:xfrm>
            <a:off x="2106790" y="293515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A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727146A9-839E-B403-47C8-CACE0AF0FE75}"/>
              </a:ext>
            </a:extLst>
          </p:cNvPr>
          <p:cNvSpPr txBox="1"/>
          <p:nvPr/>
        </p:nvSpPr>
        <p:spPr>
          <a:xfrm>
            <a:off x="2261640" y="3099213"/>
            <a:ext cx="2936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C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FC421744-D846-376F-3F56-E892F3F5486E}"/>
              </a:ext>
            </a:extLst>
          </p:cNvPr>
          <p:cNvSpPr txBox="1"/>
          <p:nvPr/>
        </p:nvSpPr>
        <p:spPr>
          <a:xfrm>
            <a:off x="5991919" y="3043649"/>
            <a:ext cx="31451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D</a:t>
            </a:r>
          </a:p>
        </p:txBody>
      </p:sp>
      <p:sp>
        <p:nvSpPr>
          <p:cNvPr id="18" name="TextBox 3">
            <a:extLst>
              <a:ext uri="{FF2B5EF4-FFF2-40B4-BE49-F238E27FC236}">
                <a16:creationId xmlns:a16="http://schemas.microsoft.com/office/drawing/2014/main" id="{9F807031-C8B6-1871-95CA-7B3B24112C14}"/>
              </a:ext>
            </a:extLst>
          </p:cNvPr>
          <p:cNvSpPr txBox="1"/>
          <p:nvPr/>
        </p:nvSpPr>
        <p:spPr>
          <a:xfrm>
            <a:off x="2189527" y="5957996"/>
            <a:ext cx="7316602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algn="just">
              <a:spcBef>
                <a:spcPts val="0"/>
              </a:spcBef>
            </a:pPr>
            <a:r>
              <a:rPr lang="en-US" sz="14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lemental Figure 3. Prognostic impact of CD8 </a:t>
            </a:r>
            <a:r>
              <a:rPr lang="en-US" sz="1400" b="1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immunoscore</a:t>
            </a:r>
            <a:r>
              <a:rPr lang="en-US" sz="14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groupings</a:t>
            </a:r>
            <a:r>
              <a:rPr lang="en-US" sz="14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. </a:t>
            </a:r>
            <a:r>
              <a:rPr lang="en-US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hown are Kaplan-Meier estimates of overall survival (A,B) and progression free survival (C,D) of OSCC patients stratified by CD8 </a:t>
            </a:r>
            <a:r>
              <a:rPr lang="en-US" sz="14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immunoscores</a:t>
            </a:r>
            <a:r>
              <a:rPr lang="en-US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.  </a:t>
            </a:r>
            <a:endParaRPr lang="en-US" sz="1400" dirty="0">
              <a:effectLst/>
              <a:latin typeface="Calibri" panose="020F0502020204030204" pitchFamily="34" charset="0"/>
              <a:ea typeface="Calibri" panose="020F0502020204030204" pitchFamily="34" charset="0"/>
              <a:cs typeface="Cordia New" panose="020B0304020202020204" pitchFamily="34" charset="-34"/>
            </a:endParaRPr>
          </a:p>
        </p:txBody>
      </p:sp>
    </p:spTree>
    <p:extLst>
      <p:ext uri="{BB962C8B-B14F-4D97-AF65-F5344CB8AC3E}">
        <p14:creationId xmlns:p14="http://schemas.microsoft.com/office/powerpoint/2010/main" val="6964967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6</Words>
  <Application>Microsoft Office PowerPoint</Application>
  <PresentationFormat>Widescreen</PresentationFormat>
  <Paragraphs>9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rism 10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urnett, Andrean L</dc:creator>
  <cp:lastModifiedBy>Burnett, Andrean L</cp:lastModifiedBy>
  <cp:revision>1</cp:revision>
  <dcterms:created xsi:type="dcterms:W3CDTF">2024-05-01T17:40:15Z</dcterms:created>
  <dcterms:modified xsi:type="dcterms:W3CDTF">2024-05-01T17:40:32Z</dcterms:modified>
</cp:coreProperties>
</file>